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61" autoAdjust="0"/>
    <p:restoredTop sz="94660"/>
  </p:normalViewPr>
  <p:slideViewPr>
    <p:cSldViewPr snapToGrid="0">
      <p:cViewPr varScale="1">
        <p:scale>
          <a:sx n="70" d="100"/>
          <a:sy n="70" d="100"/>
        </p:scale>
        <p:origin x="90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BEF8E-E0D3-4161-B877-72FB28CE4289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E9489-C048-4A74-958C-F7B9AE2F59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69098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BEF8E-E0D3-4161-B877-72FB28CE4289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E9489-C048-4A74-958C-F7B9AE2F59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33187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BEF8E-E0D3-4161-B877-72FB28CE4289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E9489-C048-4A74-958C-F7B9AE2F59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6832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BEF8E-E0D3-4161-B877-72FB28CE4289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E9489-C048-4A74-958C-F7B9AE2F59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33033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BEF8E-E0D3-4161-B877-72FB28CE4289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E9489-C048-4A74-958C-F7B9AE2F59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64562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BEF8E-E0D3-4161-B877-72FB28CE4289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E9489-C048-4A74-958C-F7B9AE2F59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22168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BEF8E-E0D3-4161-B877-72FB28CE4289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E9489-C048-4A74-958C-F7B9AE2F59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89486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BEF8E-E0D3-4161-B877-72FB28CE4289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E9489-C048-4A74-958C-F7B9AE2F59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7530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BEF8E-E0D3-4161-B877-72FB28CE4289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E9489-C048-4A74-958C-F7B9AE2F59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966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BEF8E-E0D3-4161-B877-72FB28CE4289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E9489-C048-4A74-958C-F7B9AE2F59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44562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BEF8E-E0D3-4161-B877-72FB28CE4289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E9489-C048-4A74-958C-F7B9AE2F59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11085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8BEF8E-E0D3-4161-B877-72FB28CE4289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8E9489-C048-4A74-958C-F7B9AE2F59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47102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75420974"/>
              </p:ext>
            </p:extLst>
          </p:nvPr>
        </p:nvGraphicFramePr>
        <p:xfrm>
          <a:off x="2088111" y="1037224"/>
          <a:ext cx="6751089" cy="5301615"/>
        </p:xfrm>
        <a:graphic>
          <a:graphicData uri="http://schemas.openxmlformats.org/drawingml/2006/table">
            <a:tbl>
              <a:tblPr/>
              <a:tblGrid>
                <a:gridCol w="750121"/>
                <a:gridCol w="1174210"/>
                <a:gridCol w="326032"/>
                <a:gridCol w="750121"/>
                <a:gridCol w="750121"/>
                <a:gridCol w="750121"/>
                <a:gridCol w="750121"/>
                <a:gridCol w="750121"/>
                <a:gridCol w="750121"/>
              </a:tblGrid>
              <a:tr h="443223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OVA p-valu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75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ac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6D0F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9C0006"/>
                          </a:solidFill>
                          <a:effectLst/>
                          <a:latin typeface="Calibri" panose="020F0502020204030204" pitchFamily="34" charset="0"/>
                        </a:rPr>
                        <a:t>0.00007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75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x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6D0F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6701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75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O15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6D0F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9C0006"/>
                          </a:solidFill>
                          <a:effectLst/>
                          <a:latin typeface="Calibri" panose="020F0502020204030204" pitchFamily="34" charset="0"/>
                        </a:rPr>
                        <a:t>0.04631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75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O1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6D0F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9C0006"/>
                          </a:solidFill>
                          <a:effectLst/>
                          <a:latin typeface="Calibri" panose="020F0502020204030204" pitchFamily="34" charset="0"/>
                        </a:rPr>
                        <a:t>0.04252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75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a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9C0006"/>
                          </a:solidFill>
                          <a:effectLst/>
                          <a:latin typeface="Calibri" panose="020F0502020204030204" pitchFamily="34" charset="0"/>
                        </a:rPr>
                        <a:t>0.00178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75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0347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75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GFR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9C0006"/>
                          </a:solidFill>
                          <a:effectLst/>
                          <a:latin typeface="Calibri" panose="020F0502020204030204" pitchFamily="34" charset="0"/>
                        </a:rPr>
                        <a:t>0.00204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75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av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1102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75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v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9C0006"/>
                          </a:solidFill>
                          <a:effectLst/>
                          <a:latin typeface="Calibri" panose="020F0502020204030204" pitchFamily="34" charset="0"/>
                        </a:rPr>
                        <a:t>0.00002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75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n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9C0006"/>
                          </a:solidFill>
                          <a:effectLst/>
                          <a:latin typeface="Calibri" panose="020F0502020204030204" pitchFamily="34" charset="0"/>
                        </a:rPr>
                        <a:t>0.04123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75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lx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BB9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9C0006"/>
                          </a:solidFill>
                          <a:effectLst/>
                          <a:latin typeface="Calibri" panose="020F0502020204030204" pitchFamily="34" charset="0"/>
                        </a:rPr>
                        <a:t>0.00957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75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psin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BB9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9C0006"/>
                          </a:solidFill>
                          <a:effectLst/>
                          <a:latin typeface="Calibri" panose="020F0502020204030204" pitchFamily="34" charset="0"/>
                        </a:rPr>
                        <a:t>0.00044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75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C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BB9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9C0006"/>
                          </a:solidFill>
                          <a:effectLst/>
                          <a:latin typeface="Calibri" panose="020F0502020204030204" pitchFamily="34" charset="0"/>
                        </a:rPr>
                        <a:t>0.00000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75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KC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BB9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9C0006"/>
                          </a:solidFill>
                          <a:effectLst/>
                          <a:latin typeface="Calibri" panose="020F0502020204030204" pitchFamily="34" charset="0"/>
                        </a:rPr>
                        <a:t>0.03971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75"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75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&lt;0.5 highlighted in re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75">
                <a:tc gridSpan="9"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terisks indicate significant pairwise differences between sexes/stages by Box-Cox analysi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44875">
                <a:tc gridSpan="9">
                  <a:txBody>
                    <a:bodyPr/>
                    <a:lstStyle/>
                    <a:p>
                      <a:pPr algn="l" fontAlgn="b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547311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6</TotalTime>
  <Words>53</Words>
  <Application>Microsoft Office PowerPoint</Application>
  <PresentationFormat>Widescreen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the Pacifi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jna Rivera</dc:creator>
  <cp:lastModifiedBy>Ajna Rivera</cp:lastModifiedBy>
  <cp:revision>5</cp:revision>
  <dcterms:created xsi:type="dcterms:W3CDTF">2015-06-04T18:20:52Z</dcterms:created>
  <dcterms:modified xsi:type="dcterms:W3CDTF">2015-06-19T22:52:09Z</dcterms:modified>
</cp:coreProperties>
</file>